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71" d="100"/>
          <a:sy n="171" d="100"/>
        </p:scale>
        <p:origin x="-128" y="-3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37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335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3721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920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99789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489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586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902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693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416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019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D372AE-9C96-6A4B-9385-BF7DB09E4E7D}" type="datetimeFigureOut">
              <a:rPr lang="en-US" smtClean="0"/>
              <a:t>04/0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EFB86-7DE7-C94B-BBEC-6051333BC8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46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" name="Group 51"/>
          <p:cNvGrpSpPr/>
          <p:nvPr/>
        </p:nvGrpSpPr>
        <p:grpSpPr>
          <a:xfrm>
            <a:off x="950073" y="696538"/>
            <a:ext cx="7250204" cy="5488643"/>
            <a:chOff x="648325" y="0"/>
            <a:chExt cx="7250204" cy="5488643"/>
          </a:xfrm>
        </p:grpSpPr>
        <p:sp>
          <p:nvSpPr>
            <p:cNvPr id="4" name="Magnetic Disk 3"/>
            <p:cNvSpPr/>
            <p:nvPr/>
          </p:nvSpPr>
          <p:spPr>
            <a:xfrm>
              <a:off x="2506357" y="0"/>
              <a:ext cx="1180800" cy="794802"/>
            </a:xfrm>
            <a:prstGeom prst="flowChartMagneticDisk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 err="1" smtClean="0">
                  <a:latin typeface="Times New Roman"/>
                  <a:cs typeface="Times New Roman"/>
                </a:rPr>
                <a:t>BioGRID</a:t>
              </a:r>
              <a:r>
                <a:rPr lang="en-US" sz="1000" dirty="0" smtClean="0">
                  <a:latin typeface="Times New Roman"/>
                  <a:cs typeface="Times New Roman"/>
                </a:rPr>
                <a:t> physical interactions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5" name="Decision 4"/>
            <p:cNvSpPr/>
            <p:nvPr/>
          </p:nvSpPr>
          <p:spPr>
            <a:xfrm>
              <a:off x="2298352" y="1525588"/>
              <a:ext cx="1598400" cy="986400"/>
            </a:xfrm>
            <a:prstGeom prst="flowChartDecision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evidences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6" name="Decision 5"/>
            <p:cNvSpPr/>
            <p:nvPr/>
          </p:nvSpPr>
          <p:spPr>
            <a:xfrm>
              <a:off x="4621213" y="3228975"/>
              <a:ext cx="1598400" cy="986400"/>
            </a:xfrm>
            <a:prstGeom prst="flowChartDecision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spAutoFit/>
            </a:bodyPr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publications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7" name="Decision 6"/>
            <p:cNvSpPr/>
            <p:nvPr/>
          </p:nvSpPr>
          <p:spPr>
            <a:xfrm>
              <a:off x="4621213" y="1525591"/>
              <a:ext cx="1598400" cy="986400"/>
            </a:xfrm>
            <a:prstGeom prst="flowChartDecision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wrap="square" rtlCol="0" anchor="ctr" anchorCtr="0">
              <a:spAutoFit/>
            </a:bodyPr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methods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9" name="Straight Arrow Connector 8"/>
            <p:cNvCxnSpPr>
              <a:stCxn id="4" idx="3"/>
              <a:endCxn id="5" idx="0"/>
            </p:cNvCxnSpPr>
            <p:nvPr/>
          </p:nvCxnSpPr>
          <p:spPr>
            <a:xfrm rot="16200000" flipH="1">
              <a:off x="2731761" y="1159797"/>
              <a:ext cx="730786" cy="79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Arrow Connector 10"/>
            <p:cNvCxnSpPr>
              <a:stCxn id="5" idx="3"/>
              <a:endCxn id="7" idx="1"/>
            </p:cNvCxnSpPr>
            <p:nvPr/>
          </p:nvCxnSpPr>
          <p:spPr>
            <a:xfrm>
              <a:off x="3896752" y="2018788"/>
              <a:ext cx="724461" cy="3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/>
            <p:cNvCxnSpPr>
              <a:stCxn id="7" idx="2"/>
              <a:endCxn id="6" idx="0"/>
            </p:cNvCxnSpPr>
            <p:nvPr/>
          </p:nvCxnSpPr>
          <p:spPr>
            <a:xfrm rot="5400000">
              <a:off x="5061921" y="2870483"/>
              <a:ext cx="716984" cy="1588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Connector 18"/>
            <p:cNvSpPr/>
            <p:nvPr/>
          </p:nvSpPr>
          <p:spPr>
            <a:xfrm>
              <a:off x="648325" y="1737475"/>
              <a:ext cx="936000" cy="562630"/>
            </a:xfrm>
            <a:prstGeom prst="flowChartConnector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spAutoFit/>
            </a:bodyPr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Discard data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20" name="Connector 19"/>
            <p:cNvSpPr/>
            <p:nvPr/>
          </p:nvSpPr>
          <p:spPr>
            <a:xfrm>
              <a:off x="6962529" y="3440860"/>
              <a:ext cx="936000" cy="562630"/>
            </a:xfrm>
            <a:prstGeom prst="flowChartConnector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spAutoFit/>
            </a:bodyPr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Tolerant criterion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21" name="Connector 20"/>
            <p:cNvSpPr/>
            <p:nvPr/>
          </p:nvSpPr>
          <p:spPr>
            <a:xfrm>
              <a:off x="4943781" y="4926013"/>
              <a:ext cx="936000" cy="562630"/>
            </a:xfrm>
            <a:prstGeom prst="flowChartConnector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spAutoFit/>
            </a:bodyPr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Stringent criterion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22" name="Connector 21"/>
            <p:cNvSpPr/>
            <p:nvPr/>
          </p:nvSpPr>
          <p:spPr>
            <a:xfrm>
              <a:off x="6958586" y="1733223"/>
              <a:ext cx="936000" cy="562630"/>
            </a:xfrm>
            <a:prstGeom prst="flowChartConnector">
              <a:avLst/>
            </a:prstGeom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>
              <a:spAutoFit/>
            </a:bodyPr>
            <a:lstStyle/>
            <a:p>
              <a:pPr algn="ctr"/>
              <a:r>
                <a:rPr lang="en-US" sz="1000" dirty="0" smtClean="0">
                  <a:latin typeface="Times New Roman"/>
                  <a:cs typeface="Times New Roman"/>
                </a:rPr>
                <a:t>Tolerant criterion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24" name="Straight Arrow Connector 23"/>
            <p:cNvCxnSpPr>
              <a:stCxn id="5" idx="1"/>
              <a:endCxn id="19" idx="6"/>
            </p:cNvCxnSpPr>
            <p:nvPr/>
          </p:nvCxnSpPr>
          <p:spPr>
            <a:xfrm rot="10800000" flipV="1">
              <a:off x="1584326" y="2018788"/>
              <a:ext cx="714027" cy="2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/>
            <p:cNvCxnSpPr>
              <a:stCxn id="7" idx="3"/>
              <a:endCxn id="22" idx="2"/>
            </p:cNvCxnSpPr>
            <p:nvPr/>
          </p:nvCxnSpPr>
          <p:spPr>
            <a:xfrm flipV="1">
              <a:off x="6219613" y="2014538"/>
              <a:ext cx="738973" cy="4253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>
              <a:stCxn id="6" idx="3"/>
              <a:endCxn id="20" idx="2"/>
            </p:cNvCxnSpPr>
            <p:nvPr/>
          </p:nvCxnSpPr>
          <p:spPr>
            <a:xfrm>
              <a:off x="6219613" y="3722175"/>
              <a:ext cx="742916" cy="1588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/>
            <p:cNvCxnSpPr>
              <a:stCxn id="6" idx="2"/>
              <a:endCxn id="21" idx="0"/>
            </p:cNvCxnSpPr>
            <p:nvPr/>
          </p:nvCxnSpPr>
          <p:spPr>
            <a:xfrm rot="5400000">
              <a:off x="5060778" y="4566378"/>
              <a:ext cx="710638" cy="8632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1845233" y="1772570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1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6474178" y="1772570"/>
              <a:ext cx="2616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1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6469240" y="3477542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1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5421207" y="2717446"/>
              <a:ext cx="3211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&gt;1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5421207" y="4413630"/>
              <a:ext cx="3211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&gt;1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089392" y="1772570"/>
              <a:ext cx="3211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Times New Roman"/>
                  <a:cs typeface="Times New Roman"/>
                </a:rPr>
                <a:t>&gt;1</a:t>
              </a:r>
              <a:endParaRPr lang="en-US" sz="1000" dirty="0">
                <a:latin typeface="Times New Roman"/>
                <a:cs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5152263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</Words>
  <Application>Microsoft Macintosh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 Lovell</dc:creator>
  <cp:lastModifiedBy>Simon Lovell</cp:lastModifiedBy>
  <cp:revision>1</cp:revision>
  <dcterms:created xsi:type="dcterms:W3CDTF">2013-04-04T14:31:23Z</dcterms:created>
  <dcterms:modified xsi:type="dcterms:W3CDTF">2013-04-04T14:31:58Z</dcterms:modified>
</cp:coreProperties>
</file>